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60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0299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5121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5213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5609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0966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9318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029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3608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9739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3957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248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9BF58-F949-4AFD-B325-4D75AB02C8A6}" type="datetimeFigureOut">
              <a:rPr lang="de-DE" smtClean="0"/>
              <a:t>08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C95CE-F68E-453C-9E7F-0367E35A3F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1212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7" Type="http://schemas.openxmlformats.org/officeDocument/2006/relationships/image" Target="../media/image19.tiff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Relationship Id="rId9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-1" y="559723"/>
            <a:ext cx="17764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74" t="55068" r="34371" b="2547"/>
          <a:stretch/>
        </p:blipFill>
        <p:spPr>
          <a:xfrm>
            <a:off x="191193" y="1363133"/>
            <a:ext cx="2755208" cy="2478835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60" t="62088" r="35951" b="2667"/>
          <a:stretch/>
        </p:blipFill>
        <p:spPr>
          <a:xfrm>
            <a:off x="191193" y="4343400"/>
            <a:ext cx="2746740" cy="2381766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533055" y="166166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533055" y="196616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533055" y="214755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03587" y="23023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603587" y="24537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603587" y="26902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03587" y="28834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93688" y="3155058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Gerade Verbindung mit Pfeil 18"/>
          <p:cNvCxnSpPr/>
          <p:nvPr/>
        </p:nvCxnSpPr>
        <p:spPr>
          <a:xfrm flipH="1">
            <a:off x="2506515" y="2589570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2506515" y="2936481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feld 20"/>
          <p:cNvSpPr txBox="1"/>
          <p:nvPr/>
        </p:nvSpPr>
        <p:spPr>
          <a:xfrm>
            <a:off x="2713093" y="2796412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-NT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2732329" y="2481211"/>
            <a:ext cx="787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GSDMD-FL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17025" y="1446300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612040" y="45124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612040" y="481690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612040" y="49982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82572" y="51530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82572" y="530450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82572" y="554100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682572" y="57341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72673" y="6005803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96010" y="4297045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2564707" y="5618173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2794109" y="5503350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84" t="25587" r="35600" b="43789"/>
          <a:stretch/>
        </p:blipFill>
        <p:spPr>
          <a:xfrm>
            <a:off x="3543082" y="4080667"/>
            <a:ext cx="2826329" cy="2589639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44" t="12606" r="35983" b="52121"/>
          <a:stretch/>
        </p:blipFill>
        <p:spPr>
          <a:xfrm>
            <a:off x="3524590" y="1363134"/>
            <a:ext cx="2837513" cy="2502170"/>
          </a:xfrm>
          <a:prstGeom prst="rect">
            <a:avLst/>
          </a:prstGeom>
        </p:spPr>
      </p:pic>
      <p:sp>
        <p:nvSpPr>
          <p:cNvPr id="37" name="Textfeld 36"/>
          <p:cNvSpPr txBox="1"/>
          <p:nvPr/>
        </p:nvSpPr>
        <p:spPr>
          <a:xfrm>
            <a:off x="3543082" y="15835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543082" y="189640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3543082" y="21193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613614" y="22741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3613614" y="24588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3613614" y="277013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3613614" y="29882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3603715" y="3309748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3527052" y="1368227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Gerade Verbindung mit Pfeil 45"/>
          <p:cNvCxnSpPr/>
          <p:nvPr/>
        </p:nvCxnSpPr>
        <p:spPr>
          <a:xfrm flipH="1">
            <a:off x="5925814" y="2672808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5925814" y="3019719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feld 47"/>
          <p:cNvSpPr txBox="1"/>
          <p:nvPr/>
        </p:nvSpPr>
        <p:spPr>
          <a:xfrm>
            <a:off x="3475064" y="4262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3475064" y="457559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475064" y="479023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3537773" y="49907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3545596" y="51983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545596" y="54825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3545596" y="56992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3535697" y="6085303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459034" y="408066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Gerade Verbindung mit Pfeil 56"/>
          <p:cNvCxnSpPr/>
          <p:nvPr/>
        </p:nvCxnSpPr>
        <p:spPr>
          <a:xfrm flipH="1">
            <a:off x="5894829" y="5287994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3657598" y="579367"/>
            <a:ext cx="3220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Grafik 5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08" t="18393" r="42462" b="47805"/>
          <a:stretch/>
        </p:blipFill>
        <p:spPr>
          <a:xfrm>
            <a:off x="6451127" y="1367764"/>
            <a:ext cx="2960589" cy="2474204"/>
          </a:xfrm>
          <a:prstGeom prst="rect">
            <a:avLst/>
          </a:prstGeom>
        </p:spPr>
      </p:pic>
      <p:pic>
        <p:nvPicPr>
          <p:cNvPr id="60" name="Grafik 5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30" t="58301" r="42526" b="5612"/>
          <a:stretch/>
        </p:blipFill>
        <p:spPr>
          <a:xfrm>
            <a:off x="9488900" y="1363133"/>
            <a:ext cx="2630090" cy="2451609"/>
          </a:xfrm>
          <a:prstGeom prst="rect">
            <a:avLst/>
          </a:prstGeom>
        </p:spPr>
      </p:pic>
      <p:pic>
        <p:nvPicPr>
          <p:cNvPr id="61" name="Grafik 6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42" t="12350" r="37366" b="52403"/>
          <a:stretch/>
        </p:blipFill>
        <p:spPr>
          <a:xfrm>
            <a:off x="6451127" y="4100794"/>
            <a:ext cx="2973866" cy="2555015"/>
          </a:xfrm>
          <a:prstGeom prst="rect">
            <a:avLst/>
          </a:prstGeom>
        </p:spPr>
      </p:pic>
      <p:pic>
        <p:nvPicPr>
          <p:cNvPr id="63" name="Grafik 6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69" t="55153" r="38332" b="7578"/>
          <a:stretch/>
        </p:blipFill>
        <p:spPr>
          <a:xfrm>
            <a:off x="9488900" y="4106553"/>
            <a:ext cx="2630090" cy="2549256"/>
          </a:xfrm>
          <a:prstGeom prst="rect">
            <a:avLst/>
          </a:prstGeom>
        </p:spPr>
      </p:pic>
      <p:sp>
        <p:nvSpPr>
          <p:cNvPr id="73" name="Textfeld 72"/>
          <p:cNvSpPr txBox="1"/>
          <p:nvPr/>
        </p:nvSpPr>
        <p:spPr>
          <a:xfrm>
            <a:off x="6499911" y="156180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6499911" y="18496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6499911" y="20560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6570443" y="22440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6570443" y="24619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6570443" y="27400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6570443" y="29664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6560544" y="3296275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6483881" y="1371380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9546666" y="167512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9546666" y="198793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9546666" y="22108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9617198" y="23656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9617198" y="25503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9617198" y="27785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9617198" y="29883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9607299" y="3276589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9530636" y="145975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6448036" y="420278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6448036" y="450728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6448036" y="473855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/>
          <p:cNvSpPr txBox="1"/>
          <p:nvPr/>
        </p:nvSpPr>
        <p:spPr>
          <a:xfrm>
            <a:off x="6518568" y="49265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6518568" y="51278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6518568" y="54392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6518568" y="56822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6508669" y="6037009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6432006" y="4020671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9421902" y="451204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/>
          <p:cNvSpPr txBox="1"/>
          <p:nvPr/>
        </p:nvSpPr>
        <p:spPr>
          <a:xfrm>
            <a:off x="9421902" y="482485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9421902" y="50478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9492434" y="52358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9492434" y="54205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9492434" y="57318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/>
          <p:cNvSpPr txBox="1"/>
          <p:nvPr/>
        </p:nvSpPr>
        <p:spPr>
          <a:xfrm>
            <a:off x="9492434" y="594995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9482535" y="6271451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feld 107"/>
          <p:cNvSpPr txBox="1"/>
          <p:nvPr/>
        </p:nvSpPr>
        <p:spPr>
          <a:xfrm>
            <a:off x="9405872" y="4063924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Gerade Verbindung mit Pfeil 108"/>
          <p:cNvCxnSpPr/>
          <p:nvPr/>
        </p:nvCxnSpPr>
        <p:spPr>
          <a:xfrm flipH="1">
            <a:off x="8904541" y="2547439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Gerade Verbindung mit Pfeil 109"/>
          <p:cNvCxnSpPr/>
          <p:nvPr/>
        </p:nvCxnSpPr>
        <p:spPr>
          <a:xfrm flipH="1">
            <a:off x="8904541" y="2882318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Gerade Verbindung mit Pfeil 110"/>
          <p:cNvCxnSpPr/>
          <p:nvPr/>
        </p:nvCxnSpPr>
        <p:spPr>
          <a:xfrm flipH="1">
            <a:off x="8992396" y="5336637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Gerade Verbindung mit Pfeil 111"/>
          <p:cNvCxnSpPr/>
          <p:nvPr/>
        </p:nvCxnSpPr>
        <p:spPr>
          <a:xfrm flipH="1">
            <a:off x="8992396" y="5556511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Gerade Verbindung mit Pfeil 112"/>
          <p:cNvCxnSpPr/>
          <p:nvPr/>
        </p:nvCxnSpPr>
        <p:spPr>
          <a:xfrm flipH="1">
            <a:off x="11746680" y="2571012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Gerade Verbindung mit Pfeil 113"/>
          <p:cNvCxnSpPr/>
          <p:nvPr/>
        </p:nvCxnSpPr>
        <p:spPr>
          <a:xfrm flipH="1">
            <a:off x="11754993" y="2909610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Gerade Verbindung mit Pfeil 114"/>
          <p:cNvCxnSpPr/>
          <p:nvPr/>
        </p:nvCxnSpPr>
        <p:spPr>
          <a:xfrm flipH="1">
            <a:off x="11680178" y="5550726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Gerade Verbindung mit Pfeil 115"/>
          <p:cNvCxnSpPr/>
          <p:nvPr/>
        </p:nvCxnSpPr>
        <p:spPr>
          <a:xfrm flipH="1">
            <a:off x="11680178" y="5803852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Gerader Verbinder 117"/>
          <p:cNvCxnSpPr/>
          <p:nvPr/>
        </p:nvCxnSpPr>
        <p:spPr>
          <a:xfrm>
            <a:off x="3543082" y="1147156"/>
            <a:ext cx="85759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52253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09" t="5653" r="51925" b="56673"/>
          <a:stretch/>
        </p:blipFill>
        <p:spPr>
          <a:xfrm>
            <a:off x="809356" y="3486052"/>
            <a:ext cx="2158288" cy="225155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86" t="27321" r="20287" b="17786"/>
          <a:stretch/>
        </p:blipFill>
        <p:spPr>
          <a:xfrm>
            <a:off x="4314306" y="944324"/>
            <a:ext cx="1833884" cy="2061764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27" t="16342" r="26355" b="32521"/>
          <a:stretch/>
        </p:blipFill>
        <p:spPr>
          <a:xfrm>
            <a:off x="4314306" y="3587772"/>
            <a:ext cx="1833884" cy="2100393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06" t="23608" r="6663" b="15482"/>
          <a:stretch/>
        </p:blipFill>
        <p:spPr>
          <a:xfrm>
            <a:off x="6666807" y="902967"/>
            <a:ext cx="1945179" cy="2103121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81" t="24721" r="17516" b="23001"/>
          <a:stretch/>
        </p:blipFill>
        <p:spPr>
          <a:xfrm>
            <a:off x="6666806" y="3587772"/>
            <a:ext cx="1945179" cy="2133257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55" t="16410" r="26796" b="46899"/>
          <a:stretch/>
        </p:blipFill>
        <p:spPr>
          <a:xfrm>
            <a:off x="9277003" y="902967"/>
            <a:ext cx="1961804" cy="2111432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67" t="15779" r="27079" b="47833"/>
          <a:stretch/>
        </p:blipFill>
        <p:spPr>
          <a:xfrm>
            <a:off x="9277003" y="3592970"/>
            <a:ext cx="1986743" cy="2128059"/>
          </a:xfrm>
          <a:prstGeom prst="rect">
            <a:avLst/>
          </a:prstGeom>
        </p:spPr>
      </p:pic>
      <p:sp>
        <p:nvSpPr>
          <p:cNvPr id="26" name="Textfeld 25"/>
          <p:cNvSpPr txBox="1"/>
          <p:nvPr/>
        </p:nvSpPr>
        <p:spPr>
          <a:xfrm>
            <a:off x="482318" y="964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625414" y="104524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82317" y="1210418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552850" y="154328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552850" y="16981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552850" y="19962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52850" y="21816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542951" y="2484819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40184" y="675334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12" t="6755" r="44815" b="62081"/>
          <a:stretch/>
        </p:blipFill>
        <p:spPr>
          <a:xfrm>
            <a:off x="809356" y="932634"/>
            <a:ext cx="2264710" cy="1981388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>
            <a:off x="482317" y="1387532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82318" y="363480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480890" y="3887622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30209" y="42628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28105" y="44179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516157" y="47309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516157" y="49092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506258" y="5232650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466504" y="4087934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4000482" y="10144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4000481" y="1302016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071014" y="16602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4071014" y="18387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4071014" y="21847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071014" y="23480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4061115" y="2689041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4000481" y="1495795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8949747" y="98967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8941901" y="1243733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8975984" y="16112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8975984" y="18078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8975984" y="20532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8985013" y="22564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8971035" y="2594291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8939242" y="1427488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8862784" y="37727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8854938" y="4026784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8889021" y="43942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8889021" y="45971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8889021" y="49203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8898050" y="51551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8888151" y="5491388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8852279" y="4210539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6343276" y="368872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6330528" y="3959530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6399859" y="432704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6399859" y="45193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99859" y="48531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6408888" y="503183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6398989" y="5365630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6363117" y="4143285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6367365" y="104616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6367365" y="1316972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6367365" y="16844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6367365" y="18444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6367365" y="213575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6367365" y="23480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6367365" y="2640078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6367365" y="1500727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3964373" y="372683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3964372" y="4014363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4034905" y="43725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4034905" y="45511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4034905" y="48970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034905" y="50604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4025006" y="5401388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3964372" y="4208142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-24937" y="274236"/>
            <a:ext cx="17764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/>
          <p:cNvSpPr txBox="1"/>
          <p:nvPr/>
        </p:nvSpPr>
        <p:spPr>
          <a:xfrm>
            <a:off x="4314306" y="362254"/>
            <a:ext cx="3220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Gerader Verbinder 94"/>
          <p:cNvCxnSpPr/>
          <p:nvPr/>
        </p:nvCxnSpPr>
        <p:spPr>
          <a:xfrm flipV="1">
            <a:off x="3790950" y="708131"/>
            <a:ext cx="7472796" cy="4241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feld 95"/>
          <p:cNvSpPr txBox="1"/>
          <p:nvPr/>
        </p:nvSpPr>
        <p:spPr>
          <a:xfrm>
            <a:off x="3964372" y="713185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6325827" y="713184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8916801" y="720976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Gerade Verbindung mit Pfeil 98"/>
          <p:cNvCxnSpPr/>
          <p:nvPr/>
        </p:nvCxnSpPr>
        <p:spPr>
          <a:xfrm flipH="1">
            <a:off x="2867488" y="1911180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 flipH="1">
            <a:off x="2867488" y="2258091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feld 100"/>
          <p:cNvSpPr txBox="1"/>
          <p:nvPr/>
        </p:nvSpPr>
        <p:spPr>
          <a:xfrm>
            <a:off x="3074066" y="2118022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-NT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3093302" y="1802821"/>
            <a:ext cx="787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GSDMD-FL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Gerade Verbindung mit Pfeil 102"/>
          <p:cNvCxnSpPr/>
          <p:nvPr/>
        </p:nvCxnSpPr>
        <p:spPr>
          <a:xfrm flipH="1">
            <a:off x="2791465" y="4764974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2971173" y="4650151"/>
            <a:ext cx="5950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42594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-20189" y="305229"/>
            <a:ext cx="17764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18" t="57946" r="37607" b="5074"/>
          <a:stretch/>
        </p:blipFill>
        <p:spPr>
          <a:xfrm>
            <a:off x="257868" y="896507"/>
            <a:ext cx="1943390" cy="184262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77" t="14320" r="32064" b="48700"/>
          <a:stretch/>
        </p:blipFill>
        <p:spPr>
          <a:xfrm>
            <a:off x="3058520" y="2826326"/>
            <a:ext cx="1943389" cy="1943387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92" t="59100" r="33449" b="3920"/>
          <a:stretch/>
        </p:blipFill>
        <p:spPr>
          <a:xfrm>
            <a:off x="257868" y="2826326"/>
            <a:ext cx="1943389" cy="1943387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62" t="11045" r="37463" b="51975"/>
          <a:stretch/>
        </p:blipFill>
        <p:spPr>
          <a:xfrm>
            <a:off x="3048947" y="896903"/>
            <a:ext cx="1951000" cy="184983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32" t="9799" r="42609" b="53607"/>
          <a:stretch/>
        </p:blipFill>
        <p:spPr>
          <a:xfrm>
            <a:off x="3048947" y="4856909"/>
            <a:ext cx="1951000" cy="1998202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30" t="59737" r="41611" b="3669"/>
          <a:stretch/>
        </p:blipFill>
        <p:spPr>
          <a:xfrm>
            <a:off x="256510" y="4856910"/>
            <a:ext cx="1943509" cy="1990531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58" t="20558" r="36914" b="45062"/>
          <a:stretch/>
        </p:blipFill>
        <p:spPr>
          <a:xfrm>
            <a:off x="5625270" y="936626"/>
            <a:ext cx="1931802" cy="1810115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41" t="59714" r="36031" b="5906"/>
          <a:stretch/>
        </p:blipFill>
        <p:spPr>
          <a:xfrm>
            <a:off x="8511614" y="929014"/>
            <a:ext cx="1931802" cy="1810115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48" t="8284" r="32383" b="53003"/>
          <a:stretch/>
        </p:blipFill>
        <p:spPr>
          <a:xfrm>
            <a:off x="5625270" y="2826326"/>
            <a:ext cx="1931802" cy="1875806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36" t="51688" r="32795" b="9599"/>
          <a:stretch/>
        </p:blipFill>
        <p:spPr>
          <a:xfrm>
            <a:off x="8511614" y="2826326"/>
            <a:ext cx="1931802" cy="1875806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71" t="8577" r="38650" b="52999"/>
          <a:stretch/>
        </p:blipFill>
        <p:spPr>
          <a:xfrm>
            <a:off x="5625270" y="4856908"/>
            <a:ext cx="1940870" cy="1975238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13" t="56927" r="44208" b="4649"/>
          <a:stretch/>
        </p:blipFill>
        <p:spPr>
          <a:xfrm>
            <a:off x="8502546" y="4856908"/>
            <a:ext cx="1940870" cy="1975238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-60853" y="98370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-60853" y="12401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-60853" y="140807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9679" y="15356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9679" y="16826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9679" y="19345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9679" y="20815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-220" y="2363387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-76945" y="675918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-84411" y="294915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-84411" y="320563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-84411" y="337352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-13879" y="35011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-13879" y="36480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-13879" y="38999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-13879" y="40469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-23778" y="4328839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-74512" y="48999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-74512" y="52103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-74512" y="539412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-3980" y="55375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-3980" y="56845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-3980" y="59364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-3980" y="608346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-13879" y="6365316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-84192" y="4702132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Gerade Verbindung mit Pfeil 49"/>
          <p:cNvCxnSpPr/>
          <p:nvPr/>
        </p:nvCxnSpPr>
        <p:spPr>
          <a:xfrm flipH="1">
            <a:off x="1756259" y="2004618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1823223" y="3913368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H="1">
            <a:off x="1843216" y="5907163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2146698" y="3778902"/>
            <a:ext cx="5212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p-I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2152617" y="1887773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2124549" y="5787829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685462" y="97905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2685462" y="123553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2685462" y="140342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2755994" y="15310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2755994" y="16779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2755994" y="19299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2755994" y="20768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2746095" y="2358740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2669370" y="675918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2713641" y="282604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2713641" y="308252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2713641" y="325041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2784173" y="33779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2784173" y="35249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2784173" y="377688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2784173" y="39238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2774274" y="4205728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2713641" y="495000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2713641" y="52064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2713641" y="537437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2784173" y="55019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2784173" y="56489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2784173" y="59008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2784173" y="60478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2774274" y="6329687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5292102" y="103561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5292102" y="125399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5292102" y="142950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5362634" y="15647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5362634" y="17345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5362634" y="19255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5362634" y="20877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5352735" y="2369582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5276010" y="675918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5273565" y="294214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5273565" y="319861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/>
          <p:cNvSpPr txBox="1"/>
          <p:nvPr/>
        </p:nvSpPr>
        <p:spPr>
          <a:xfrm>
            <a:off x="5273565" y="336651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5344097" y="34940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5344097" y="36410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5344097" y="38701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5344097" y="40171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5334198" y="4291347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/>
          <p:cNvSpPr txBox="1"/>
          <p:nvPr/>
        </p:nvSpPr>
        <p:spPr>
          <a:xfrm>
            <a:off x="5283464" y="507064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5283464" y="53347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5283464" y="548739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5353996" y="56302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5353996" y="57848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/>
          <p:cNvSpPr txBox="1"/>
          <p:nvPr/>
        </p:nvSpPr>
        <p:spPr>
          <a:xfrm>
            <a:off x="5353996" y="60214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5353996" y="61837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feld 107"/>
          <p:cNvSpPr txBox="1"/>
          <p:nvPr/>
        </p:nvSpPr>
        <p:spPr>
          <a:xfrm>
            <a:off x="5344097" y="6488426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feld 109"/>
          <p:cNvSpPr txBox="1"/>
          <p:nvPr/>
        </p:nvSpPr>
        <p:spPr>
          <a:xfrm>
            <a:off x="8162147" y="93724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8162147" y="119371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8162147" y="136161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feld 112"/>
          <p:cNvSpPr txBox="1"/>
          <p:nvPr/>
        </p:nvSpPr>
        <p:spPr>
          <a:xfrm>
            <a:off x="8232679" y="14891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8232679" y="16361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8232679" y="18880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8232679" y="20350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8222780" y="2316927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8146055" y="675918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feld 118"/>
          <p:cNvSpPr txBox="1"/>
          <p:nvPr/>
        </p:nvSpPr>
        <p:spPr>
          <a:xfrm>
            <a:off x="8162147" y="295081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8162147" y="314632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8162147" y="332184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8232679" y="344180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8232679" y="36040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8232679" y="38483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8232679" y="40105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8222780" y="4223817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feld 127"/>
          <p:cNvSpPr txBox="1"/>
          <p:nvPr/>
        </p:nvSpPr>
        <p:spPr>
          <a:xfrm>
            <a:off x="8162147" y="497234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8162147" y="522882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8162147" y="53967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/>
          <p:cNvSpPr txBox="1"/>
          <p:nvPr/>
        </p:nvSpPr>
        <p:spPr>
          <a:xfrm>
            <a:off x="8232679" y="55242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/>
          <p:cNvSpPr txBox="1"/>
          <p:nvPr/>
        </p:nvSpPr>
        <p:spPr>
          <a:xfrm>
            <a:off x="8232679" y="56712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132"/>
          <p:cNvSpPr txBox="1"/>
          <p:nvPr/>
        </p:nvSpPr>
        <p:spPr>
          <a:xfrm>
            <a:off x="8232679" y="59231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feld 133"/>
          <p:cNvSpPr txBox="1"/>
          <p:nvPr/>
        </p:nvSpPr>
        <p:spPr>
          <a:xfrm>
            <a:off x="8232679" y="6070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8222780" y="6321549"/>
            <a:ext cx="3356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Gerade Verbindung mit Pfeil 136"/>
          <p:cNvCxnSpPr/>
          <p:nvPr/>
        </p:nvCxnSpPr>
        <p:spPr>
          <a:xfrm flipH="1">
            <a:off x="4537559" y="2004618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Gerade Verbindung mit Pfeil 137"/>
          <p:cNvCxnSpPr/>
          <p:nvPr/>
        </p:nvCxnSpPr>
        <p:spPr>
          <a:xfrm flipH="1">
            <a:off x="4560419" y="3833077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H="1">
            <a:off x="4659328" y="5895166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/>
          <p:nvPr/>
        </p:nvCxnSpPr>
        <p:spPr>
          <a:xfrm flipH="1">
            <a:off x="7271322" y="1934547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 flipH="1">
            <a:off x="7202742" y="3846334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 flipH="1">
            <a:off x="7271322" y="5908122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 flipH="1">
            <a:off x="10090722" y="1885028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Gerade Verbindung mit Pfeil 143"/>
          <p:cNvCxnSpPr/>
          <p:nvPr/>
        </p:nvCxnSpPr>
        <p:spPr>
          <a:xfrm flipH="1">
            <a:off x="10022142" y="3833077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Gerade Verbindung mit Pfeil 144"/>
          <p:cNvCxnSpPr/>
          <p:nvPr/>
        </p:nvCxnSpPr>
        <p:spPr>
          <a:xfrm flipH="1">
            <a:off x="10045002" y="5806882"/>
            <a:ext cx="2857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feld 145"/>
          <p:cNvSpPr txBox="1"/>
          <p:nvPr/>
        </p:nvSpPr>
        <p:spPr>
          <a:xfrm>
            <a:off x="2774274" y="305229"/>
            <a:ext cx="3220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Gerader Verbinder 146"/>
          <p:cNvCxnSpPr/>
          <p:nvPr/>
        </p:nvCxnSpPr>
        <p:spPr>
          <a:xfrm flipV="1">
            <a:off x="2667995" y="613006"/>
            <a:ext cx="77754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37256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84351" y="45426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5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2184822" y="144641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/>
          <p:cNvCxnSpPr/>
          <p:nvPr/>
        </p:nvCxnSpPr>
        <p:spPr>
          <a:xfrm flipH="1">
            <a:off x="2152995" y="4516501"/>
            <a:ext cx="349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feld 11"/>
          <p:cNvSpPr txBox="1"/>
          <p:nvPr/>
        </p:nvSpPr>
        <p:spPr>
          <a:xfrm>
            <a:off x="2437054" y="4401085"/>
            <a:ext cx="6976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SC-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341838" y="47806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5E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4" t="9408" r="43841" b="28476"/>
          <a:stretch/>
        </p:blipFill>
        <p:spPr>
          <a:xfrm>
            <a:off x="3418740" y="1175516"/>
            <a:ext cx="1837113" cy="1787236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3341838" y="94468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4" t="13757" r="37145" b="16328"/>
          <a:stretch/>
        </p:blipFill>
        <p:spPr>
          <a:xfrm>
            <a:off x="3418740" y="3280444"/>
            <a:ext cx="1837113" cy="1716531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5530170" y="4486867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Gerade Verbindung mit Pfeil 17"/>
          <p:cNvCxnSpPr/>
          <p:nvPr/>
        </p:nvCxnSpPr>
        <p:spPr>
          <a:xfrm flipH="1">
            <a:off x="5255853" y="4602283"/>
            <a:ext cx="349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6260845" y="449701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5F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95" t="18943" r="14745" b="16053"/>
          <a:stretch/>
        </p:blipFill>
        <p:spPr>
          <a:xfrm>
            <a:off x="6260845" y="1147157"/>
            <a:ext cx="1521230" cy="1870363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6198968" y="90801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62" t="31366" r="24906" b="11431"/>
          <a:stretch/>
        </p:blipFill>
        <p:spPr>
          <a:xfrm>
            <a:off x="6260844" y="3252085"/>
            <a:ext cx="1370239" cy="1773251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9297763" y="449700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5G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59" t="14609" r="29293" b="18365"/>
          <a:stretch/>
        </p:blipFill>
        <p:spPr>
          <a:xfrm>
            <a:off x="9410007" y="1118061"/>
            <a:ext cx="1679171" cy="1928554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08" t="19310" r="33992" b="21176"/>
          <a:stretch/>
        </p:blipFill>
        <p:spPr>
          <a:xfrm>
            <a:off x="9410007" y="3312913"/>
            <a:ext cx="1612670" cy="1712423"/>
          </a:xfrm>
          <a:prstGeom prst="rect">
            <a:avLst/>
          </a:prstGeom>
        </p:spPr>
      </p:pic>
      <p:sp>
        <p:nvSpPr>
          <p:cNvPr id="26" name="Textfeld 25"/>
          <p:cNvSpPr txBox="1"/>
          <p:nvPr/>
        </p:nvSpPr>
        <p:spPr>
          <a:xfrm>
            <a:off x="11147367" y="4458508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Gerade Verbindung mit Pfeil 26"/>
          <p:cNvCxnSpPr/>
          <p:nvPr/>
        </p:nvCxnSpPr>
        <p:spPr>
          <a:xfrm flipH="1">
            <a:off x="10873050" y="4573924"/>
            <a:ext cx="349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feld 27"/>
          <p:cNvSpPr txBox="1"/>
          <p:nvPr/>
        </p:nvSpPr>
        <p:spPr>
          <a:xfrm>
            <a:off x="7925509" y="4142509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Gerade Verbindung mit Pfeil 28"/>
          <p:cNvCxnSpPr/>
          <p:nvPr/>
        </p:nvCxnSpPr>
        <p:spPr>
          <a:xfrm flipH="1">
            <a:off x="7651192" y="4257925"/>
            <a:ext cx="349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r Verbinder 30"/>
          <p:cNvCxnSpPr/>
          <p:nvPr/>
        </p:nvCxnSpPr>
        <p:spPr>
          <a:xfrm>
            <a:off x="5363918" y="1757406"/>
            <a:ext cx="0" cy="120534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5349725" y="2244663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4D8T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r Verbinder 32"/>
          <p:cNvCxnSpPr/>
          <p:nvPr/>
        </p:nvCxnSpPr>
        <p:spPr>
          <a:xfrm>
            <a:off x="7820791" y="1986742"/>
            <a:ext cx="0" cy="106306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7820791" y="2331720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yo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Gerader Verbinder 35"/>
          <p:cNvCxnSpPr/>
          <p:nvPr/>
        </p:nvCxnSpPr>
        <p:spPr>
          <a:xfrm>
            <a:off x="11147367" y="1645920"/>
            <a:ext cx="0" cy="140388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11147367" y="2331720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4D8T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63" t="26174" r="49753" b="16622"/>
          <a:stretch/>
        </p:blipFill>
        <p:spPr>
          <a:xfrm>
            <a:off x="260466" y="1118061"/>
            <a:ext cx="1715425" cy="1816332"/>
          </a:xfrm>
          <a:prstGeom prst="rect">
            <a:avLst/>
          </a:prstGeom>
        </p:spPr>
      </p:pic>
      <p:cxnSp>
        <p:nvCxnSpPr>
          <p:cNvPr id="8" name="Gerade Verbindung mit Pfeil 7"/>
          <p:cNvCxnSpPr/>
          <p:nvPr/>
        </p:nvCxnSpPr>
        <p:spPr>
          <a:xfrm flipH="1">
            <a:off x="1878677" y="1561831"/>
            <a:ext cx="349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2" t="3735" r="41326" b="28372"/>
          <a:stretch/>
        </p:blipFill>
        <p:spPr>
          <a:xfrm>
            <a:off x="166254" y="3416530"/>
            <a:ext cx="1986741" cy="1953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8955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7</Words>
  <Application>Microsoft Office PowerPoint</Application>
  <PresentationFormat>Breitbild</PresentationFormat>
  <Paragraphs>278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äder, Christina</dc:creator>
  <cp:lastModifiedBy>Mäder, Christina</cp:lastModifiedBy>
  <cp:revision>19</cp:revision>
  <dcterms:created xsi:type="dcterms:W3CDTF">2024-03-27T08:38:00Z</dcterms:created>
  <dcterms:modified xsi:type="dcterms:W3CDTF">2025-05-08T13:10:14Z</dcterms:modified>
</cp:coreProperties>
</file>